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999538" cy="162004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塩澤 拓亮" initials="塩澤" lastIdx="2" clrIdx="0">
    <p:extLst>
      <p:ext uri="{19B8F6BF-5375-455C-9EA6-DF929625EA0E}">
        <p15:presenceInfo xmlns:p15="http://schemas.microsoft.com/office/powerpoint/2012/main" userId="S::t.shiozawa@ncnpchiiki.onmicrosoft.com::f3457297-cc9f-4809-9664-d7c1bc7b3f7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5865" autoAdjust="0"/>
  </p:normalViewPr>
  <p:slideViewPr>
    <p:cSldViewPr snapToGrid="0">
      <p:cViewPr varScale="1">
        <p:scale>
          <a:sx n="41" d="100"/>
          <a:sy n="41" d="100"/>
        </p:scale>
        <p:origin x="253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651323"/>
            <a:ext cx="7649607" cy="5640152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8508981"/>
            <a:ext cx="6749654" cy="3911355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77667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789556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862524"/>
            <a:ext cx="1940525" cy="1372912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862524"/>
            <a:ext cx="5709082" cy="1372912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02566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007252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4038864"/>
            <a:ext cx="7762102" cy="6738931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10841548"/>
            <a:ext cx="7762102" cy="3543845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314794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4312617"/>
            <a:ext cx="3824804" cy="1027902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4312617"/>
            <a:ext cx="3824804" cy="1027902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302566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862527"/>
            <a:ext cx="7762102" cy="313133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971359"/>
            <a:ext cx="3807226" cy="194630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5917660"/>
            <a:ext cx="3807226" cy="870398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971359"/>
            <a:ext cx="3825976" cy="194630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5917660"/>
            <a:ext cx="3825976" cy="870398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382702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672883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935925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1080029"/>
            <a:ext cx="2902585" cy="378010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2332567"/>
            <a:ext cx="4556016" cy="11512811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860131"/>
            <a:ext cx="2902585" cy="900399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361424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1080029"/>
            <a:ext cx="2902585" cy="3780102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2332567"/>
            <a:ext cx="4556016" cy="11512811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860131"/>
            <a:ext cx="2902585" cy="900399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128519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862527"/>
            <a:ext cx="7762102" cy="3131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4312617"/>
            <a:ext cx="7762102" cy="102790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5015410"/>
            <a:ext cx="2024896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68D82A-9E31-4719-9898-ED97895C0794}" type="datetimeFigureOut">
              <a:rPr kumimoji="1" lang="en-GB" smtClean="0"/>
              <a:t>09/07/2021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5015410"/>
            <a:ext cx="3037344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5015410"/>
            <a:ext cx="2024896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D4EB3-DFF3-4136-8873-F25E070675CB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502617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903232ED-5E51-4675-AE2A-3653DDE3A3F2}"/>
              </a:ext>
            </a:extLst>
          </p:cNvPr>
          <p:cNvCxnSpPr>
            <a:cxnSpLocks/>
          </p:cNvCxnSpPr>
          <p:nvPr/>
        </p:nvCxnSpPr>
        <p:spPr>
          <a:xfrm>
            <a:off x="2033769" y="4936944"/>
            <a:ext cx="4932000" cy="0"/>
          </a:xfrm>
          <a:prstGeom prst="line">
            <a:avLst/>
          </a:prstGeom>
          <a:noFill/>
          <a:ln w="63500" cap="flat" cmpd="sng" algn="ctr">
            <a:solidFill>
              <a:srgbClr val="000000"/>
            </a:solidFill>
            <a:prstDash val="solid"/>
          </a:ln>
          <a:effectLst/>
        </p:spPr>
      </p:cxn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2FEF49B6-926E-456A-ACE2-DAF41DC0788B}"/>
              </a:ext>
            </a:extLst>
          </p:cNvPr>
          <p:cNvSpPr/>
          <p:nvPr/>
        </p:nvSpPr>
        <p:spPr bwMode="auto">
          <a:xfrm>
            <a:off x="287788" y="14170714"/>
            <a:ext cx="3564000" cy="1800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u="sng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Intention-to-treat analysis</a:t>
            </a:r>
          </a:p>
          <a:p>
            <a:pPr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Vocational outcomes (n = 75)</a:t>
            </a:r>
          </a:p>
          <a:p>
            <a:pPr lvl="0">
              <a:spcBef>
                <a:spcPct val="0"/>
              </a:spcBef>
              <a:spcAft>
                <a:spcPts val="554"/>
              </a:spcAft>
              <a:defRPr/>
            </a:pPr>
            <a:r>
              <a:rPr lang="ja-JP" altLang="en-US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　　</a:t>
            </a:r>
            <a:r>
              <a:rPr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PROMs </a:t>
            </a:r>
          </a:p>
          <a:p>
            <a:pPr marL="266700" lvl="0">
              <a:spcBef>
                <a:spcPct val="0"/>
              </a:spcBef>
              <a:spcAft>
                <a:spcPts val="554"/>
              </a:spcAft>
              <a:defRPr/>
            </a:pPr>
            <a:r>
              <a:rPr lang="ja-JP" altLang="en-US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・</a:t>
            </a:r>
            <a:r>
              <a:rPr kumimoji="0"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WHO-Five Well-being Index (n = 51)</a:t>
            </a:r>
          </a:p>
          <a:p>
            <a:pPr marL="266700" lvl="0">
              <a:spcBef>
                <a:spcPct val="0"/>
              </a:spcBef>
              <a:spcAft>
                <a:spcPts val="554"/>
              </a:spcAft>
              <a:defRPr/>
            </a:pPr>
            <a:r>
              <a:rPr lang="ja-JP" altLang="en-US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・</a:t>
            </a:r>
            <a:r>
              <a:rPr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INSPIRE (n = 37)</a:t>
            </a:r>
            <a:endParaRPr kumimoji="0" lang="en-US" altLang="ja-JP" sz="1500" b="1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B2BB8F42-9481-41E3-B497-D879AC1D4B5B}"/>
              </a:ext>
            </a:extLst>
          </p:cNvPr>
          <p:cNvSpPr/>
          <p:nvPr/>
        </p:nvSpPr>
        <p:spPr bwMode="auto">
          <a:xfrm>
            <a:off x="227989" y="1012541"/>
            <a:ext cx="8460000" cy="684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u="none" strike="noStrike" kern="0" cap="none" spc="0" normalizeH="0" baseline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20 agencies offered individualized supported employment services</a:t>
            </a:r>
            <a:endParaRPr kumimoji="0" lang="en-US" altLang="ja-JP" sz="1900" b="1" u="none" strike="noStrike" kern="0" cap="none" spc="0" normalizeH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17CC9F3C-E7E6-45B4-86BE-D7E570C04972}"/>
              </a:ext>
            </a:extLst>
          </p:cNvPr>
          <p:cNvSpPr/>
          <p:nvPr/>
        </p:nvSpPr>
        <p:spPr>
          <a:xfrm>
            <a:off x="6029769" y="1810895"/>
            <a:ext cx="2700000" cy="972000"/>
          </a:xfrm>
          <a:prstGeom prst="rect">
            <a:avLst/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174625" indent="-174625">
              <a:buFont typeface="Arial" panose="020B0604020202020204" pitchFamily="34" charset="0"/>
              <a:buChar char="•"/>
            </a:pPr>
            <a:r>
              <a:rPr kumimoji="1" lang="en-GB" sz="1200" dirty="0">
                <a:solidFill>
                  <a:schemeClr val="tx1"/>
                </a:solidFill>
              </a:rPr>
              <a:t>No longer offered supported employment services (k = 1) </a:t>
            </a:r>
          </a:p>
          <a:p>
            <a:pPr marL="174625" indent="-174625">
              <a:buFont typeface="Arial" panose="020B0604020202020204" pitchFamily="34" charset="0"/>
              <a:buChar char="•"/>
            </a:pPr>
            <a:r>
              <a:rPr kumimoji="1" lang="en-US" sz="1200" dirty="0">
                <a:solidFill>
                  <a:schemeClr val="tx1"/>
                </a:solidFill>
              </a:rPr>
              <a:t>Declined due to lack of human resources for research work (k = 2</a:t>
            </a:r>
            <a:r>
              <a:rPr kumimoji="1" lang="en-US" sz="1200" dirty="0"/>
              <a:t>)</a:t>
            </a:r>
            <a:endParaRPr kumimoji="1" lang="en-GB" sz="1200" dirty="0"/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78D06DA1-ADD8-47E4-9B37-1E5363EE8843}"/>
              </a:ext>
            </a:extLst>
          </p:cNvPr>
          <p:cNvSpPr/>
          <p:nvPr/>
        </p:nvSpPr>
        <p:spPr>
          <a:xfrm>
            <a:off x="6034682" y="3692994"/>
            <a:ext cx="2700000" cy="540000"/>
          </a:xfrm>
          <a:prstGeom prst="rect">
            <a:avLst/>
          </a:prstGeom>
          <a:noFill/>
          <a:ln w="635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174625" indent="-174625">
              <a:buFont typeface="Arial" panose="020B0604020202020204" pitchFamily="34" charset="0"/>
              <a:buChar char="•"/>
            </a:pPr>
            <a:r>
              <a:rPr kumimoji="1" lang="en-US" sz="1200" dirty="0">
                <a:solidFill>
                  <a:schemeClr val="tx1"/>
                </a:solidFill>
              </a:rPr>
              <a:t>Stopped offering supported employment program before the study was initiated (k = 1)</a:t>
            </a:r>
            <a:r>
              <a:rPr kumimoji="1" lang="en-GB" sz="1200" dirty="0">
                <a:solidFill>
                  <a:schemeClr val="tx1"/>
                </a:solidFill>
              </a:rPr>
              <a:t> </a:t>
            </a: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3E37DEC1-CD30-4F75-909C-DEC146AC5DA1}"/>
              </a:ext>
            </a:extLst>
          </p:cNvPr>
          <p:cNvCxnSpPr>
            <a:cxnSpLocks/>
          </p:cNvCxnSpPr>
          <p:nvPr/>
        </p:nvCxnSpPr>
        <p:spPr>
          <a:xfrm>
            <a:off x="4457990" y="2296895"/>
            <a:ext cx="1584000" cy="0"/>
          </a:xfrm>
          <a:prstGeom prst="line">
            <a:avLst/>
          </a:prstGeom>
          <a:noFill/>
          <a:ln w="38100" cap="flat" cmpd="sng" algn="ctr">
            <a:solidFill>
              <a:srgbClr val="000000"/>
            </a:solidFill>
            <a:prstDash val="solid"/>
          </a:ln>
          <a:effectLst/>
        </p:spPr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DFF13F96-454E-490B-BBBE-E7183DE422F0}"/>
              </a:ext>
            </a:extLst>
          </p:cNvPr>
          <p:cNvCxnSpPr>
            <a:cxnSpLocks/>
          </p:cNvCxnSpPr>
          <p:nvPr/>
        </p:nvCxnSpPr>
        <p:spPr>
          <a:xfrm>
            <a:off x="4457990" y="3853107"/>
            <a:ext cx="1584000" cy="0"/>
          </a:xfrm>
          <a:prstGeom prst="line">
            <a:avLst/>
          </a:prstGeom>
          <a:noFill/>
          <a:ln w="38100" cap="flat" cmpd="sng" algn="ctr">
            <a:solidFill>
              <a:srgbClr val="000000"/>
            </a:solidFill>
            <a:prstDash val="solid"/>
          </a:ln>
          <a:effectLst/>
        </p:spPr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D8AC8AEC-699F-4F5E-8ABF-2BB4F045CFC5}"/>
              </a:ext>
            </a:extLst>
          </p:cNvPr>
          <p:cNvCxnSpPr>
            <a:cxnSpLocks/>
          </p:cNvCxnSpPr>
          <p:nvPr/>
        </p:nvCxnSpPr>
        <p:spPr>
          <a:xfrm>
            <a:off x="4457990" y="1696944"/>
            <a:ext cx="0" cy="324000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844D7ECB-BAA4-4D0F-95BD-944DF6F0E2F6}"/>
              </a:ext>
            </a:extLst>
          </p:cNvPr>
          <p:cNvSpPr/>
          <p:nvPr/>
        </p:nvSpPr>
        <p:spPr bwMode="auto">
          <a:xfrm>
            <a:off x="287788" y="2858797"/>
            <a:ext cx="8460000" cy="684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u="none" strike="noStrike" kern="0" cap="none" spc="0" normalizeH="0" baseline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17 agencies agreed to participate during the study periods</a:t>
            </a:r>
            <a:endParaRPr kumimoji="0" lang="en-US" altLang="ja-JP" sz="1900" b="1" u="none" strike="noStrike" kern="0" cap="none" spc="0" normalizeH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C0DC70AD-D2A9-4E3E-A24D-3E7501BD4BEF}"/>
              </a:ext>
            </a:extLst>
          </p:cNvPr>
          <p:cNvSpPr/>
          <p:nvPr/>
        </p:nvSpPr>
        <p:spPr bwMode="auto">
          <a:xfrm>
            <a:off x="3086097" y="4024405"/>
            <a:ext cx="2743785" cy="684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Registered</a:t>
            </a:r>
            <a:r>
              <a:rPr kumimoji="0" lang="en-US" altLang="ja-JP" sz="1900" b="1" u="none" strike="noStrike" kern="0" cap="none" spc="0" normalizeH="0" baseline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in 16 agencies</a:t>
            </a:r>
            <a:endParaRPr kumimoji="0" lang="en-US" altLang="ja-JP" sz="1900" b="1" u="none" strike="noStrike" kern="0" cap="none" spc="0" normalizeH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</p:txBody>
      </p: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E7589DE7-0496-484C-9593-5590DE138AB9}"/>
              </a:ext>
            </a:extLst>
          </p:cNvPr>
          <p:cNvCxnSpPr>
            <a:cxnSpLocks/>
          </p:cNvCxnSpPr>
          <p:nvPr/>
        </p:nvCxnSpPr>
        <p:spPr>
          <a:xfrm>
            <a:off x="2051765" y="4918714"/>
            <a:ext cx="0" cy="9252000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F733736C-B1DA-465E-B4BB-78D18F8ED4FA}"/>
              </a:ext>
            </a:extLst>
          </p:cNvPr>
          <p:cNvSpPr/>
          <p:nvPr/>
        </p:nvSpPr>
        <p:spPr bwMode="auto">
          <a:xfrm>
            <a:off x="287788" y="5427505"/>
            <a:ext cx="3564000" cy="684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900" b="1" u="sng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Low-fidelity programs</a:t>
            </a: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(k = </a:t>
            </a:r>
            <a:r>
              <a:rPr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6</a:t>
            </a: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)</a:t>
            </a:r>
            <a:r>
              <a:rPr kumimoji="0" lang="en-US" altLang="ja-JP" sz="1900" b="1" kern="0" noProof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</a:t>
            </a:r>
            <a:endParaRPr kumimoji="0" lang="en-US" altLang="ja-JP" sz="1900" b="1" u="none" strike="noStrike" kern="0" cap="none" spc="0" normalizeH="0" baseline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265113" lvl="0" indent="-171450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Assessed for eligibility (n = </a:t>
            </a:r>
            <a:r>
              <a:rPr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81</a:t>
            </a: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) </a:t>
            </a: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7BDE746C-6797-4407-8EC0-65DAD5E7AC63}"/>
              </a:ext>
            </a:extLst>
          </p:cNvPr>
          <p:cNvSpPr/>
          <p:nvPr/>
        </p:nvSpPr>
        <p:spPr bwMode="auto">
          <a:xfrm>
            <a:off x="287788" y="7326552"/>
            <a:ext cx="3564000" cy="1656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t" anchorCtr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40000"/>
              </a:lnSpc>
              <a:spcBef>
                <a:spcPct val="0"/>
              </a:spcBef>
              <a:spcAft>
                <a:spcPts val="554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9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Enrolled (n = </a:t>
            </a:r>
            <a:r>
              <a:rPr lang="en-US" altLang="ja-JP" sz="19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77</a:t>
            </a:r>
            <a:r>
              <a:rPr kumimoji="0" lang="en-US" altLang="ja-JP" sz="19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)</a:t>
            </a:r>
          </a:p>
          <a:p>
            <a:pPr marL="268288" lvl="0" indent="-17145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t enrolled due to being</a:t>
            </a:r>
            <a:r>
              <a:rPr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</a:t>
            </a: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employed at baseline assessment and no service needs (n</a:t>
            </a:r>
            <a:r>
              <a:rPr lang="ja-JP" alt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</a:t>
            </a: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=1)</a:t>
            </a:r>
          </a:p>
          <a:p>
            <a:pPr marL="174625" lvl="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defRPr/>
            </a:pPr>
            <a:endParaRPr lang="en-US" sz="12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174625" lvl="0" algn="ctr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Completion of PROMs (n = 51)</a:t>
            </a:r>
          </a:p>
          <a:p>
            <a:pPr marL="268288" lvl="0" indent="-171450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eclined to complete PROMs for no particular reason (n = 20)</a:t>
            </a:r>
          </a:p>
          <a:p>
            <a:pPr marL="268288" lvl="0" indent="-171450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 response (n = 6)</a:t>
            </a:r>
            <a:endParaRPr kumimoji="0" lang="en-GB" sz="1754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E05F0F6B-0865-416C-BE22-32D80F91DC52}"/>
              </a:ext>
            </a:extLst>
          </p:cNvPr>
          <p:cNvSpPr/>
          <p:nvPr/>
        </p:nvSpPr>
        <p:spPr bwMode="auto">
          <a:xfrm>
            <a:off x="287788" y="6377847"/>
            <a:ext cx="3564000" cy="684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lvl="0" algn="ctr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Eligible participants (n = </a:t>
            </a:r>
            <a:r>
              <a:rPr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78</a:t>
            </a: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)</a:t>
            </a:r>
          </a:p>
          <a:p>
            <a:pPr marL="268288" lvl="0" indent="-174625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t enrolled due to age under 20 years (n = 3)</a:t>
            </a: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A9CA1D90-FD2F-478E-BB51-E21B89CD5085}"/>
              </a:ext>
            </a:extLst>
          </p:cNvPr>
          <p:cNvSpPr/>
          <p:nvPr/>
        </p:nvSpPr>
        <p:spPr bwMode="auto">
          <a:xfrm>
            <a:off x="287788" y="9332985"/>
            <a:ext cx="3564000" cy="4500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algn="ctr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Consent withdrawal (n = 2)</a:t>
            </a:r>
            <a:endParaRPr lang="en-US" altLang="ja-JP" sz="1900" b="1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lvl="0" algn="ctr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Loss to follow-up (n = 8)</a:t>
            </a:r>
          </a:p>
          <a:p>
            <a:pPr marL="268288" lvl="0" indent="-17145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left program (n = 8)</a:t>
            </a:r>
            <a:endParaRPr lang="en-US" sz="1200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174625" lvl="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   </a:t>
            </a:r>
            <a:endParaRPr lang="en-US" altLang="ja-JP" sz="105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174625"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id not complete PROMs at 12-month follow-up (n = 14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eclined to complete PROMs for no particular reason (n = 9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Almost no utilization of program by follow-up assessment (n = 3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 contact at follow-up assessment to due to participants’ work (n = </a:t>
            </a:r>
            <a:r>
              <a:rPr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2</a:t>
            </a: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)</a:t>
            </a:r>
          </a:p>
          <a:p>
            <a:pPr marL="268288" indent="-174625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endParaRPr lang="en-US" altLang="ja-JP" sz="1200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93663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id not complete PROMs at 24-month follow-up (n = 14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ecline to complete PROMs for no particular reason (n = 4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Almost no utilization of program by follow-up assessment (n = 7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 contact at follow-up assessment to due to participants’ work (n = 3)</a:t>
            </a: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036DD9DA-C852-4B4A-A712-69D7B808183B}"/>
              </a:ext>
            </a:extLst>
          </p:cNvPr>
          <p:cNvSpPr/>
          <p:nvPr/>
        </p:nvSpPr>
        <p:spPr bwMode="auto">
          <a:xfrm>
            <a:off x="5165769" y="14183418"/>
            <a:ext cx="3564000" cy="1800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u="sng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Intention-to-treat analysis</a:t>
            </a:r>
          </a:p>
          <a:p>
            <a:pPr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Vocational outcomes (n = 127)</a:t>
            </a:r>
          </a:p>
          <a:p>
            <a:pPr lvl="0">
              <a:spcBef>
                <a:spcPct val="0"/>
              </a:spcBef>
              <a:spcAft>
                <a:spcPts val="554"/>
              </a:spcAft>
              <a:defRPr/>
            </a:pPr>
            <a:r>
              <a:rPr lang="ja-JP" altLang="en-US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　　</a:t>
            </a:r>
            <a:r>
              <a:rPr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PROMs </a:t>
            </a:r>
          </a:p>
          <a:p>
            <a:pPr marL="266700" lvl="0">
              <a:spcBef>
                <a:spcPct val="0"/>
              </a:spcBef>
              <a:spcAft>
                <a:spcPts val="554"/>
              </a:spcAft>
              <a:defRPr/>
            </a:pPr>
            <a:r>
              <a:rPr lang="ja-JP" altLang="en-US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・</a:t>
            </a:r>
            <a:r>
              <a:rPr kumimoji="0"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WHO-Five Well-being Index (n = 79)</a:t>
            </a:r>
          </a:p>
          <a:p>
            <a:pPr marL="266700" lvl="0">
              <a:spcBef>
                <a:spcPct val="0"/>
              </a:spcBef>
              <a:spcAft>
                <a:spcPts val="554"/>
              </a:spcAft>
              <a:defRPr/>
            </a:pPr>
            <a:r>
              <a:rPr lang="ja-JP" altLang="en-US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・</a:t>
            </a:r>
            <a:r>
              <a:rPr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INSPIRE (n = 58)</a:t>
            </a:r>
            <a:endParaRPr kumimoji="0" lang="en-US" altLang="ja-JP" sz="1500" b="1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FC6406E1-60A2-4F60-96F6-95C980EABE6E}"/>
              </a:ext>
            </a:extLst>
          </p:cNvPr>
          <p:cNvCxnSpPr>
            <a:cxnSpLocks/>
          </p:cNvCxnSpPr>
          <p:nvPr/>
        </p:nvCxnSpPr>
        <p:spPr>
          <a:xfrm>
            <a:off x="6947769" y="4927850"/>
            <a:ext cx="0" cy="9252000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EEA54849-4E22-4206-9C2A-2D83AB4C0364}"/>
              </a:ext>
            </a:extLst>
          </p:cNvPr>
          <p:cNvSpPr/>
          <p:nvPr/>
        </p:nvSpPr>
        <p:spPr bwMode="auto">
          <a:xfrm>
            <a:off x="5165769" y="9332985"/>
            <a:ext cx="3564000" cy="4500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algn="ctr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Consent withdrawal (n = 2)</a:t>
            </a:r>
            <a:endParaRPr lang="en-US" altLang="ja-JP" sz="1900" b="1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lvl="0" algn="ctr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Loss to follow-up (n = 19)</a:t>
            </a:r>
          </a:p>
          <a:p>
            <a:pPr marL="268288" lvl="0" indent="-17145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left program (n = 19)</a:t>
            </a:r>
            <a:endParaRPr lang="en-US" altLang="ja-JP" sz="1200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174625" lvl="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   </a:t>
            </a:r>
            <a:endParaRPr lang="en-US" altLang="ja-JP" sz="105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174625" lvl="0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id not complete PROMs at 12 months   follow-up (n = </a:t>
            </a:r>
            <a:r>
              <a:rPr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21</a:t>
            </a:r>
            <a:r>
              <a:rPr kumimoji="0"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eclined to complete PROMs for no particular reason (n = 8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Almost no utilization of program by follow-up assessment (n = 4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 contact at follow-up assessment to due to participants’ work (n = 9)</a:t>
            </a:r>
          </a:p>
          <a:p>
            <a:pPr marL="268288" indent="-174625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endParaRPr lang="en-US" altLang="ja-JP" sz="1200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93663" algn="ctr"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id not complete PROMs at 24 months   follow-up (n = 30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eclined to complete PROMs for no particular reason (n = 6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Almost no utilization of program by follow-up assessment (n = 10)</a:t>
            </a:r>
          </a:p>
          <a:p>
            <a:pPr marL="268288" indent="-174625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 contact at follow-up assessment to due to participants’ work (n = 14)</a:t>
            </a:r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A8F064EB-FB2A-46F2-9C64-5396264F16F3}"/>
              </a:ext>
            </a:extLst>
          </p:cNvPr>
          <p:cNvSpPr/>
          <p:nvPr/>
        </p:nvSpPr>
        <p:spPr bwMode="auto">
          <a:xfrm>
            <a:off x="5165769" y="7326552"/>
            <a:ext cx="3564000" cy="1656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t" anchorCtr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40000"/>
              </a:lnSpc>
              <a:spcBef>
                <a:spcPct val="0"/>
              </a:spcBef>
              <a:spcAft>
                <a:spcPts val="554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9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Enrolled (n = 129)</a:t>
            </a:r>
          </a:p>
          <a:p>
            <a:pPr marL="268288" lvl="0" indent="-17145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t enrolled due to being employed at baseline assessment and no service needs (n =3)</a:t>
            </a:r>
          </a:p>
          <a:p>
            <a:pPr marL="174625" lvl="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defRPr/>
            </a:pPr>
            <a:endParaRPr lang="en-US" sz="12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  <a:p>
            <a:pPr marL="174625" lvl="0" algn="ctr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sz="15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Completion of PROMs (n = 79)</a:t>
            </a:r>
          </a:p>
          <a:p>
            <a:pPr marL="268288" lvl="0" indent="-171450">
              <a:lnSpc>
                <a:spcPts val="11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Declined to complete PROMs for no particular reason (n = 35)</a:t>
            </a:r>
          </a:p>
          <a:p>
            <a:pPr marL="268288" lvl="0" indent="-171450">
              <a:lnSpc>
                <a:spcPts val="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 response (n = 15)</a:t>
            </a:r>
            <a:endParaRPr kumimoji="0" lang="en-GB" sz="1754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FE28E032-014F-4615-8696-1D8B62038420}"/>
              </a:ext>
            </a:extLst>
          </p:cNvPr>
          <p:cNvSpPr/>
          <p:nvPr/>
        </p:nvSpPr>
        <p:spPr bwMode="auto">
          <a:xfrm>
            <a:off x="5165769" y="6373779"/>
            <a:ext cx="3564000" cy="684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lvl="0" algn="ctr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defRPr/>
            </a:pP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Eligible participants (n = 132)</a:t>
            </a:r>
          </a:p>
          <a:p>
            <a:pPr marL="268288" lvl="0" indent="-171450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Not enrolled due to age under 20 years (n = 6)</a:t>
            </a:r>
            <a:endParaRPr kumimoji="0" lang="en-US" sz="1200" kern="0" dirty="0">
              <a:latin typeface="Calibri" panose="020F0502020204030204" pitchFamily="34" charset="0"/>
              <a:ea typeface="Meiryo UI" panose="020B0604030504040204" pitchFamily="50" charset="-128"/>
              <a:cs typeface="Calibri" panose="020F050202020403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88B774C4-46D1-4064-BBBB-97211F3C8994}"/>
              </a:ext>
            </a:extLst>
          </p:cNvPr>
          <p:cNvSpPr/>
          <p:nvPr/>
        </p:nvSpPr>
        <p:spPr bwMode="auto">
          <a:xfrm>
            <a:off x="5147752" y="5429578"/>
            <a:ext cx="3563943" cy="684000"/>
          </a:xfrm>
          <a:prstGeom prst="rect">
            <a:avLst/>
          </a:prstGeom>
          <a:solidFill>
            <a:srgbClr val="FFFFFF">
              <a:lumMod val="85000"/>
            </a:srgbClr>
          </a:solidFill>
          <a:ln>
            <a:solidFill>
              <a:srgbClr val="4D4D4D"/>
            </a:solidFill>
          </a:ln>
          <a:effectLst/>
        </p:spPr>
        <p:txBody>
          <a:bodyPr wrap="square" lIns="0" tIns="0" rIns="0" bIns="0" rtlCol="0" anchor="ctr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900" b="1" u="sng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High-fidelity programs</a:t>
            </a:r>
            <a:r>
              <a:rPr kumimoji="0" lang="en-US" altLang="ja-JP" sz="1900" b="1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 (k = 10)</a:t>
            </a:r>
          </a:p>
          <a:p>
            <a:pPr marL="265113" lvl="0" indent="-171450">
              <a:lnSpc>
                <a:spcPts val="1900"/>
              </a:lnSpc>
              <a:spcBef>
                <a:spcPct val="0"/>
              </a:spcBef>
              <a:spcAft>
                <a:spcPts val="554"/>
              </a:spcAft>
              <a:buFont typeface="Arial" panose="020B0604020202020204" pitchFamily="34" charset="0"/>
              <a:buChar char="•"/>
              <a:defRPr/>
            </a:pP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Assessed for eligibility (n = 13</a:t>
            </a:r>
            <a:r>
              <a:rPr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8</a:t>
            </a:r>
            <a:r>
              <a:rPr kumimoji="0" lang="en-US" altLang="ja-JP" sz="1200" kern="0" dirty="0">
                <a:latin typeface="Calibri" panose="020F0502020204030204" pitchFamily="34" charset="0"/>
                <a:ea typeface="Meiryo UI" panose="020B0604030504040204" pitchFamily="50" charset="-128"/>
                <a:cs typeface="Calibri" panose="020F0502020204030204" pitchFamily="34" charset="0"/>
              </a:rPr>
              <a:t>) </a:t>
            </a: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A939C8B5-C111-4677-8C7B-576AA459FEEF}"/>
              </a:ext>
            </a:extLst>
          </p:cNvPr>
          <p:cNvSpPr txBox="1"/>
          <p:nvPr/>
        </p:nvSpPr>
        <p:spPr>
          <a:xfrm>
            <a:off x="118962" y="282604"/>
            <a:ext cx="8745120" cy="4770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2500" b="1" dirty="0">
                <a:latin typeface="Seoge UI"/>
              </a:rPr>
              <a:t>Supplementary Figure 1. Recruitment process flow diagram</a:t>
            </a:r>
          </a:p>
        </p:txBody>
      </p:sp>
    </p:spTree>
    <p:extLst>
      <p:ext uri="{BB962C8B-B14F-4D97-AF65-F5344CB8AC3E}">
        <p14:creationId xmlns:p14="http://schemas.microsoft.com/office/powerpoint/2010/main" val="2275919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563</Words>
  <Application>Microsoft Office PowerPoint</Application>
  <PresentationFormat>ユーザー設定</PresentationFormat>
  <Paragraphs>6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Seoge UI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創生 山口</dc:creator>
  <cp:lastModifiedBy>山口 創生</cp:lastModifiedBy>
  <cp:revision>11</cp:revision>
  <dcterms:created xsi:type="dcterms:W3CDTF">2020-12-01T12:41:02Z</dcterms:created>
  <dcterms:modified xsi:type="dcterms:W3CDTF">2021-07-08T15:25:19Z</dcterms:modified>
</cp:coreProperties>
</file>